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PK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799B23B-EC83-4686-B30A-512413B5E67A}" styleName="Light Style 3 - Accent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3B4B98B0-60AC-42C2-AFA5-B58CD77FA1E5}" styleName="Light Style 1 - Accent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2" d="100"/>
          <a:sy n="72" d="100"/>
        </p:scale>
        <p:origin x="660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5AA5DF-3087-4CEA-B562-2B7799949C6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PK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CD515C6-7BDA-4FBE-AD62-982063DB2D5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PK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1C596CA-86F6-4F7D-BA30-94AED80E41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ABD949-1D81-4ECC-8822-2B3A833F33A0}" type="datetimeFigureOut">
              <a:rPr lang="en-PK" smtClean="0"/>
              <a:t>15/08/2021</a:t>
            </a:fld>
            <a:endParaRPr lang="en-PK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BC447E6-1861-47E2-949F-C42114498E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K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B323359-23BD-44A7-93D2-9C97FC96F7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D965C6-6219-4C94-A297-C2B3829FD441}" type="slidenum">
              <a:rPr lang="en-PK" smtClean="0"/>
              <a:t>‹#›</a:t>
            </a:fld>
            <a:endParaRPr lang="en-PK"/>
          </a:p>
        </p:txBody>
      </p:sp>
    </p:spTree>
    <p:extLst>
      <p:ext uri="{BB962C8B-B14F-4D97-AF65-F5344CB8AC3E}">
        <p14:creationId xmlns:p14="http://schemas.microsoft.com/office/powerpoint/2010/main" val="40129092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40484AB-4019-4601-A7BF-BB6DC7A4D38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PK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FE747BC-920E-4FA8-85D1-00387CD1527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PK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5D85B5C-A062-42E8-AF65-19C30E5CE0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ABD949-1D81-4ECC-8822-2B3A833F33A0}" type="datetimeFigureOut">
              <a:rPr lang="en-PK" smtClean="0"/>
              <a:t>15/08/2021</a:t>
            </a:fld>
            <a:endParaRPr lang="en-PK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DE725CB-B33A-457B-9B4C-B73451C825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K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655CE65-256B-4FE2-980C-9167578D04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D965C6-6219-4C94-A297-C2B3829FD441}" type="slidenum">
              <a:rPr lang="en-PK" smtClean="0"/>
              <a:t>‹#›</a:t>
            </a:fld>
            <a:endParaRPr lang="en-PK"/>
          </a:p>
        </p:txBody>
      </p:sp>
    </p:spTree>
    <p:extLst>
      <p:ext uri="{BB962C8B-B14F-4D97-AF65-F5344CB8AC3E}">
        <p14:creationId xmlns:p14="http://schemas.microsoft.com/office/powerpoint/2010/main" val="42197480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FFCAE01-C69B-481A-9A7F-35F658A02AB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PK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BC7EC02-EABD-49F4-ABEA-5C0CE3E406E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PK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DDB4A05-E129-4CAC-A553-B9491037F1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ABD949-1D81-4ECC-8822-2B3A833F33A0}" type="datetimeFigureOut">
              <a:rPr lang="en-PK" smtClean="0"/>
              <a:t>15/08/2021</a:t>
            </a:fld>
            <a:endParaRPr lang="en-PK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8383496-3726-418F-A220-8948D0FF2C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K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76217DB-E6AB-4537-AA10-B647C770C8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D965C6-6219-4C94-A297-C2B3829FD441}" type="slidenum">
              <a:rPr lang="en-PK" smtClean="0"/>
              <a:t>‹#›</a:t>
            </a:fld>
            <a:endParaRPr lang="en-PK"/>
          </a:p>
        </p:txBody>
      </p:sp>
    </p:spTree>
    <p:extLst>
      <p:ext uri="{BB962C8B-B14F-4D97-AF65-F5344CB8AC3E}">
        <p14:creationId xmlns:p14="http://schemas.microsoft.com/office/powerpoint/2010/main" val="5750540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953B86-613A-49FB-8954-BB126EE8856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PK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38D5DAB-E5D5-4C42-982C-AC45E6B00CA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PK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621C13C-532B-4E67-9415-6B077F27F4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ABD949-1D81-4ECC-8822-2B3A833F33A0}" type="datetimeFigureOut">
              <a:rPr lang="en-PK" smtClean="0"/>
              <a:t>15/08/2021</a:t>
            </a:fld>
            <a:endParaRPr lang="en-PK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16A0205-764B-41D4-90E3-F36E8D1663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K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0821E38-E040-4D86-B370-CF58640BBD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D965C6-6219-4C94-A297-C2B3829FD441}" type="slidenum">
              <a:rPr lang="en-PK" smtClean="0"/>
              <a:t>‹#›</a:t>
            </a:fld>
            <a:endParaRPr lang="en-PK"/>
          </a:p>
        </p:txBody>
      </p:sp>
    </p:spTree>
    <p:extLst>
      <p:ext uri="{BB962C8B-B14F-4D97-AF65-F5344CB8AC3E}">
        <p14:creationId xmlns:p14="http://schemas.microsoft.com/office/powerpoint/2010/main" val="35780161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D6302E-FBAD-46DE-BFD5-5997C4CBE9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PK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05EF602-C7CF-463D-9207-8E656A56AE5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A79B694-A94B-475E-87DE-34A5BF8329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ABD949-1D81-4ECC-8822-2B3A833F33A0}" type="datetimeFigureOut">
              <a:rPr lang="en-PK" smtClean="0"/>
              <a:t>15/08/2021</a:t>
            </a:fld>
            <a:endParaRPr lang="en-PK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277A647-AED2-4BFE-B31D-5F8EF76CEA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K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70482BB-09D7-4D52-B285-7B9E84CED9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D965C6-6219-4C94-A297-C2B3829FD441}" type="slidenum">
              <a:rPr lang="en-PK" smtClean="0"/>
              <a:t>‹#›</a:t>
            </a:fld>
            <a:endParaRPr lang="en-PK"/>
          </a:p>
        </p:txBody>
      </p:sp>
    </p:spTree>
    <p:extLst>
      <p:ext uri="{BB962C8B-B14F-4D97-AF65-F5344CB8AC3E}">
        <p14:creationId xmlns:p14="http://schemas.microsoft.com/office/powerpoint/2010/main" val="41071739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9BAF8E-B70D-46C3-8747-4A14CF3B1DC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PK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4A53F2A-2C2E-4238-AD63-19E3210D14D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PK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91385F5-9C60-4618-A961-87A4916B331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PK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0B46FF5-84E3-49D4-83F0-3095405769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ABD949-1D81-4ECC-8822-2B3A833F33A0}" type="datetimeFigureOut">
              <a:rPr lang="en-PK" smtClean="0"/>
              <a:t>15/08/2021</a:t>
            </a:fld>
            <a:endParaRPr lang="en-PK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C8AA608-AC75-4DFF-9EAA-1196F0D999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K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326FC90-9486-4A6E-A62D-F3EE3FA9E1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D965C6-6219-4C94-A297-C2B3829FD441}" type="slidenum">
              <a:rPr lang="en-PK" smtClean="0"/>
              <a:t>‹#›</a:t>
            </a:fld>
            <a:endParaRPr lang="en-PK"/>
          </a:p>
        </p:txBody>
      </p:sp>
    </p:spTree>
    <p:extLst>
      <p:ext uri="{BB962C8B-B14F-4D97-AF65-F5344CB8AC3E}">
        <p14:creationId xmlns:p14="http://schemas.microsoft.com/office/powerpoint/2010/main" val="6929423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C8039D4-8C28-4F28-8DE2-7DD5870A6E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PK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47ECE9D-3488-49A7-ACCD-A9030B5A067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834BA2F-968E-4084-A355-FAA7F317221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PK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4054ECD-04F7-4096-B331-09FCB8C7E55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C620E3A-5B14-402D-8D06-9492C75560B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PK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64A2EC6-7627-4180-B20F-F105B2B9ED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ABD949-1D81-4ECC-8822-2B3A833F33A0}" type="datetimeFigureOut">
              <a:rPr lang="en-PK" smtClean="0"/>
              <a:t>15/08/2021</a:t>
            </a:fld>
            <a:endParaRPr lang="en-PK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52C5630-B9F0-4D71-B0D1-5B7B243F7E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K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C3DA048-13F3-4B52-B1FB-AA2396D4DA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D965C6-6219-4C94-A297-C2B3829FD441}" type="slidenum">
              <a:rPr lang="en-PK" smtClean="0"/>
              <a:t>‹#›</a:t>
            </a:fld>
            <a:endParaRPr lang="en-PK"/>
          </a:p>
        </p:txBody>
      </p:sp>
    </p:spTree>
    <p:extLst>
      <p:ext uri="{BB962C8B-B14F-4D97-AF65-F5344CB8AC3E}">
        <p14:creationId xmlns:p14="http://schemas.microsoft.com/office/powerpoint/2010/main" val="40937487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4F96513-3C1D-4907-B442-205B510786F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PK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C3992C0-DEC6-43E9-A163-6A31D55384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ABD949-1D81-4ECC-8822-2B3A833F33A0}" type="datetimeFigureOut">
              <a:rPr lang="en-PK" smtClean="0"/>
              <a:t>15/08/2021</a:t>
            </a:fld>
            <a:endParaRPr lang="en-PK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D8BECC8-2768-4BEA-9D76-032EF8946E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K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86FE812-0C19-405F-888B-6AFCCA18F8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D965C6-6219-4C94-A297-C2B3829FD441}" type="slidenum">
              <a:rPr lang="en-PK" smtClean="0"/>
              <a:t>‹#›</a:t>
            </a:fld>
            <a:endParaRPr lang="en-PK"/>
          </a:p>
        </p:txBody>
      </p:sp>
    </p:spTree>
    <p:extLst>
      <p:ext uri="{BB962C8B-B14F-4D97-AF65-F5344CB8AC3E}">
        <p14:creationId xmlns:p14="http://schemas.microsoft.com/office/powerpoint/2010/main" val="42602613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EE34003-5EF9-45AB-B731-0D97591BC3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ABD949-1D81-4ECC-8822-2B3A833F33A0}" type="datetimeFigureOut">
              <a:rPr lang="en-PK" smtClean="0"/>
              <a:t>15/08/2021</a:t>
            </a:fld>
            <a:endParaRPr lang="en-PK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8FB9375-BA29-4546-85F1-B518A816DE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K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62A19C8-13E3-414E-9725-32273EC35B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D965C6-6219-4C94-A297-C2B3829FD441}" type="slidenum">
              <a:rPr lang="en-PK" smtClean="0"/>
              <a:t>‹#›</a:t>
            </a:fld>
            <a:endParaRPr lang="en-PK"/>
          </a:p>
        </p:txBody>
      </p:sp>
    </p:spTree>
    <p:extLst>
      <p:ext uri="{BB962C8B-B14F-4D97-AF65-F5344CB8AC3E}">
        <p14:creationId xmlns:p14="http://schemas.microsoft.com/office/powerpoint/2010/main" val="41887486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55913D6-D6C2-4559-99BF-425208F54C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PK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B4006D7-AD47-4113-A2FE-A6FA5154ECD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PK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CB100D0-CB49-43FA-89DA-E51AA02989F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50FBB17-4796-44FE-B7E3-BDA94A8492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ABD949-1D81-4ECC-8822-2B3A833F33A0}" type="datetimeFigureOut">
              <a:rPr lang="en-PK" smtClean="0"/>
              <a:t>15/08/2021</a:t>
            </a:fld>
            <a:endParaRPr lang="en-PK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5596470-A250-4C43-84F1-3C36491441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K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A467066-53FB-4902-91E6-83D5A8FCFB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D965C6-6219-4C94-A297-C2B3829FD441}" type="slidenum">
              <a:rPr lang="en-PK" smtClean="0"/>
              <a:t>‹#›</a:t>
            </a:fld>
            <a:endParaRPr lang="en-PK"/>
          </a:p>
        </p:txBody>
      </p:sp>
    </p:spTree>
    <p:extLst>
      <p:ext uri="{BB962C8B-B14F-4D97-AF65-F5344CB8AC3E}">
        <p14:creationId xmlns:p14="http://schemas.microsoft.com/office/powerpoint/2010/main" val="827088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5E213B-8E65-483B-AEF1-28A2814F0C3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PK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A25EDDB-06F9-4871-BEFD-67932AA2343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PK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F3AD440-8733-401B-85B3-E193D6AF2A4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A2D5D7A-F31E-4645-A54C-3999398C5F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ABD949-1D81-4ECC-8822-2B3A833F33A0}" type="datetimeFigureOut">
              <a:rPr lang="en-PK" smtClean="0"/>
              <a:t>15/08/2021</a:t>
            </a:fld>
            <a:endParaRPr lang="en-PK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10DDC0D-7569-4F50-985B-A56469A01F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K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789B7D5-8E37-4048-8268-787D20AA2B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D965C6-6219-4C94-A297-C2B3829FD441}" type="slidenum">
              <a:rPr lang="en-PK" smtClean="0"/>
              <a:t>‹#›</a:t>
            </a:fld>
            <a:endParaRPr lang="en-PK"/>
          </a:p>
        </p:txBody>
      </p:sp>
    </p:spTree>
    <p:extLst>
      <p:ext uri="{BB962C8B-B14F-4D97-AF65-F5344CB8AC3E}">
        <p14:creationId xmlns:p14="http://schemas.microsoft.com/office/powerpoint/2010/main" val="16251330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16AA8AC-6457-4719-8FBE-AA4E0583A8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PK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271BF0E-A7F3-4E07-8671-45E97DAADDB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PK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A6E5463-A3C5-4EA1-A495-952BFD0FA03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ABD949-1D81-4ECC-8822-2B3A833F33A0}" type="datetimeFigureOut">
              <a:rPr lang="en-PK" smtClean="0"/>
              <a:t>15/08/2021</a:t>
            </a:fld>
            <a:endParaRPr lang="en-PK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0C882C7-3476-4076-BC1A-92FA60D0C71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PK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FE260F6-B16E-48C8-AF1A-CF07C2BDD00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D965C6-6219-4C94-A297-C2B3829FD441}" type="slidenum">
              <a:rPr lang="en-PK" smtClean="0"/>
              <a:t>‹#›</a:t>
            </a:fld>
            <a:endParaRPr lang="en-PK"/>
          </a:p>
        </p:txBody>
      </p:sp>
    </p:spTree>
    <p:extLst>
      <p:ext uri="{BB962C8B-B14F-4D97-AF65-F5344CB8AC3E}">
        <p14:creationId xmlns:p14="http://schemas.microsoft.com/office/powerpoint/2010/main" val="11101951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PK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1041CBDF-A666-425A-BFCA-724E678839C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07130060"/>
              </p:ext>
            </p:extLst>
          </p:nvPr>
        </p:nvGraphicFramePr>
        <p:xfrm>
          <a:off x="0" y="0"/>
          <a:ext cx="12192000" cy="6803160"/>
        </p:xfrm>
        <a:graphic>
          <a:graphicData uri="http://schemas.openxmlformats.org/drawingml/2006/table">
            <a:tbl>
              <a:tblPr firstRow="1" bandRow="1">
                <a:tableStyleId>{9D7B26C5-4107-4FEC-AEDC-1716B250A1EF}</a:tableStyleId>
              </a:tblPr>
              <a:tblGrid>
                <a:gridCol w="866719">
                  <a:extLst>
                    <a:ext uri="{9D8B030D-6E8A-4147-A177-3AD203B41FA5}">
                      <a16:colId xmlns:a16="http://schemas.microsoft.com/office/drawing/2014/main" val="2336675648"/>
                    </a:ext>
                  </a:extLst>
                </a:gridCol>
                <a:gridCol w="2034361">
                  <a:extLst>
                    <a:ext uri="{9D8B030D-6E8A-4147-A177-3AD203B41FA5}">
                      <a16:colId xmlns:a16="http://schemas.microsoft.com/office/drawing/2014/main" val="1572741371"/>
                    </a:ext>
                  </a:extLst>
                </a:gridCol>
                <a:gridCol w="2211224">
                  <a:extLst>
                    <a:ext uri="{9D8B030D-6E8A-4147-A177-3AD203B41FA5}">
                      <a16:colId xmlns:a16="http://schemas.microsoft.com/office/drawing/2014/main" val="3653911606"/>
                    </a:ext>
                  </a:extLst>
                </a:gridCol>
                <a:gridCol w="1730430">
                  <a:extLst>
                    <a:ext uri="{9D8B030D-6E8A-4147-A177-3AD203B41FA5}">
                      <a16:colId xmlns:a16="http://schemas.microsoft.com/office/drawing/2014/main" val="3168978598"/>
                    </a:ext>
                  </a:extLst>
                </a:gridCol>
                <a:gridCol w="1941636">
                  <a:extLst>
                    <a:ext uri="{9D8B030D-6E8A-4147-A177-3AD203B41FA5}">
                      <a16:colId xmlns:a16="http://schemas.microsoft.com/office/drawing/2014/main" val="3079576023"/>
                    </a:ext>
                  </a:extLst>
                </a:gridCol>
                <a:gridCol w="2118499">
                  <a:extLst>
                    <a:ext uri="{9D8B030D-6E8A-4147-A177-3AD203B41FA5}">
                      <a16:colId xmlns:a16="http://schemas.microsoft.com/office/drawing/2014/main" val="693242015"/>
                    </a:ext>
                  </a:extLst>
                </a:gridCol>
                <a:gridCol w="1289131">
                  <a:extLst>
                    <a:ext uri="{9D8B030D-6E8A-4147-A177-3AD203B41FA5}">
                      <a16:colId xmlns:a16="http://schemas.microsoft.com/office/drawing/2014/main" val="2320376369"/>
                    </a:ext>
                  </a:extLst>
                </a:gridCol>
              </a:tblGrid>
              <a:tr h="164592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History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Outcome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cute Injury last 3 months (Yes / No)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Suspicion of meniscal injury 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X ray done before MRI? Yes /No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MRI contraindications (See table 1)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Guidelines followed 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extLst>
                  <a:ext uri="{0D108BD9-81ED-4DB2-BD59-A6C34878D82A}">
                    <a16:rowId xmlns:a16="http://schemas.microsoft.com/office/drawing/2014/main" val="1426445726"/>
                  </a:ext>
                </a:extLst>
              </a:tr>
              <a:tr h="164592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Degenerativ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onservative  with injection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PK" sz="1100" u="none" strike="noStrike">
                          <a:effectLst/>
                        </a:rPr>
                        <a:t>6</a:t>
                      </a:r>
                      <a:endParaRPr lang="en-PK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extLst>
                  <a:ext uri="{0D108BD9-81ED-4DB2-BD59-A6C34878D82A}">
                    <a16:rowId xmlns:a16="http://schemas.microsoft.com/office/drawing/2014/main" val="3805615008"/>
                  </a:ext>
                </a:extLst>
              </a:tr>
              <a:tr h="164592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Degenerativ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onservative  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Ye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extLst>
                  <a:ext uri="{0D108BD9-81ED-4DB2-BD59-A6C34878D82A}">
                    <a16:rowId xmlns:a16="http://schemas.microsoft.com/office/drawing/2014/main" val="3682849710"/>
                  </a:ext>
                </a:extLst>
              </a:tr>
              <a:tr h="164592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Traum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operated for repair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Ye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extLst>
                  <a:ext uri="{0D108BD9-81ED-4DB2-BD59-A6C34878D82A}">
                    <a16:rowId xmlns:a16="http://schemas.microsoft.com/office/drawing/2014/main" val="4099097759"/>
                  </a:ext>
                </a:extLst>
              </a:tr>
              <a:tr h="164592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Degenerativ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onservativ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PK" sz="1100" u="none" strike="noStrike">
                          <a:effectLst/>
                        </a:rPr>
                        <a:t>1</a:t>
                      </a:r>
                      <a:endParaRPr lang="en-PK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extLst>
                  <a:ext uri="{0D108BD9-81ED-4DB2-BD59-A6C34878D82A}">
                    <a16:rowId xmlns:a16="http://schemas.microsoft.com/office/drawing/2014/main" val="2149170653"/>
                  </a:ext>
                </a:extLst>
              </a:tr>
              <a:tr h="164592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Degenerativ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onservativ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PK" sz="1100" u="none" strike="noStrike">
                          <a:effectLst/>
                        </a:rPr>
                        <a:t>1,4,5</a:t>
                      </a:r>
                      <a:endParaRPr lang="en-PK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extLst>
                  <a:ext uri="{0D108BD9-81ED-4DB2-BD59-A6C34878D82A}">
                    <a16:rowId xmlns:a16="http://schemas.microsoft.com/office/drawing/2014/main" val="1882927096"/>
                  </a:ext>
                </a:extLst>
              </a:tr>
              <a:tr h="164592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Degenerativ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onservativ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Ye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PK" sz="1100" u="none" strike="noStrike">
                          <a:effectLst/>
                        </a:rPr>
                        <a:t>1,4,5</a:t>
                      </a:r>
                      <a:endParaRPr lang="en-PK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extLst>
                  <a:ext uri="{0D108BD9-81ED-4DB2-BD59-A6C34878D82A}">
                    <a16:rowId xmlns:a16="http://schemas.microsoft.com/office/drawing/2014/main" val="1064138787"/>
                  </a:ext>
                </a:extLst>
              </a:tr>
              <a:tr h="164592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Degenerativ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onservative 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Ye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Ye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PK" sz="1100" u="none" strike="noStrike">
                          <a:effectLst/>
                        </a:rPr>
                        <a:t>1,4,5</a:t>
                      </a:r>
                      <a:endParaRPr lang="en-PK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extLst>
                  <a:ext uri="{0D108BD9-81ED-4DB2-BD59-A6C34878D82A}">
                    <a16:rowId xmlns:a16="http://schemas.microsoft.com/office/drawing/2014/main" val="344401446"/>
                  </a:ext>
                </a:extLst>
              </a:tr>
              <a:tr h="164592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Degenerativ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onservativ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PK" sz="1100" u="none" strike="noStrike">
                          <a:effectLst/>
                        </a:rPr>
                        <a:t>1,4,5</a:t>
                      </a:r>
                      <a:endParaRPr lang="en-PK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extLst>
                  <a:ext uri="{0D108BD9-81ED-4DB2-BD59-A6C34878D82A}">
                    <a16:rowId xmlns:a16="http://schemas.microsoft.com/office/drawing/2014/main" val="2489698234"/>
                  </a:ext>
                </a:extLst>
              </a:tr>
              <a:tr h="164592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Degenerativ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onservativ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Ye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PK" sz="1100" u="none" strike="noStrike">
                          <a:effectLst/>
                        </a:rPr>
                        <a:t>1,4,5</a:t>
                      </a:r>
                      <a:endParaRPr lang="en-PK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extLst>
                  <a:ext uri="{0D108BD9-81ED-4DB2-BD59-A6C34878D82A}">
                    <a16:rowId xmlns:a16="http://schemas.microsoft.com/office/drawing/2014/main" val="4273523252"/>
                  </a:ext>
                </a:extLst>
              </a:tr>
              <a:tr h="164592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Degenerativ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onservativ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PK" sz="1100" u="none" strike="noStrike">
                          <a:effectLst/>
                        </a:rPr>
                        <a:t>1,4,5</a:t>
                      </a:r>
                      <a:endParaRPr lang="en-PK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extLst>
                  <a:ext uri="{0D108BD9-81ED-4DB2-BD59-A6C34878D82A}">
                    <a16:rowId xmlns:a16="http://schemas.microsoft.com/office/drawing/2014/main" val="2404156869"/>
                  </a:ext>
                </a:extLst>
              </a:tr>
              <a:tr h="164592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Degenerativ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onservativ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Ye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Ye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extLst>
                  <a:ext uri="{0D108BD9-81ED-4DB2-BD59-A6C34878D82A}">
                    <a16:rowId xmlns:a16="http://schemas.microsoft.com/office/drawing/2014/main" val="2546201233"/>
                  </a:ext>
                </a:extLst>
              </a:tr>
              <a:tr h="164592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Degenerativ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onservativ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Ye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PK" sz="1100" u="none" strike="noStrike">
                          <a:effectLst/>
                        </a:rPr>
                        <a:t>1,4,5</a:t>
                      </a:r>
                      <a:endParaRPr lang="en-PK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extLst>
                  <a:ext uri="{0D108BD9-81ED-4DB2-BD59-A6C34878D82A}">
                    <a16:rowId xmlns:a16="http://schemas.microsoft.com/office/drawing/2014/main" val="1138762518"/>
                  </a:ext>
                </a:extLst>
              </a:tr>
              <a:tr h="164592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Traum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booked for arthroscopy and repair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Ye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Ye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extLst>
                  <a:ext uri="{0D108BD9-81ED-4DB2-BD59-A6C34878D82A}">
                    <a16:rowId xmlns:a16="http://schemas.microsoft.com/office/drawing/2014/main" val="1575419321"/>
                  </a:ext>
                </a:extLst>
              </a:tr>
              <a:tr h="164592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Degenerativ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onservative 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PK" sz="1100" u="none" strike="noStrike">
                          <a:effectLst/>
                        </a:rPr>
                        <a:t>1,4,5,7</a:t>
                      </a:r>
                      <a:endParaRPr lang="en-PK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extLst>
                  <a:ext uri="{0D108BD9-81ED-4DB2-BD59-A6C34878D82A}">
                    <a16:rowId xmlns:a16="http://schemas.microsoft.com/office/drawing/2014/main" val="1604636359"/>
                  </a:ext>
                </a:extLst>
              </a:tr>
              <a:tr h="164592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Degenerativ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onservativ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PK" sz="1100" u="none" strike="noStrike">
                          <a:effectLst/>
                        </a:rPr>
                        <a:t>5</a:t>
                      </a:r>
                      <a:endParaRPr lang="en-PK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extLst>
                  <a:ext uri="{0D108BD9-81ED-4DB2-BD59-A6C34878D82A}">
                    <a16:rowId xmlns:a16="http://schemas.microsoft.com/office/drawing/2014/main" val="2025911654"/>
                  </a:ext>
                </a:extLst>
              </a:tr>
              <a:tr h="164592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Degenerativ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onservativ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Ye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Ye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extLst>
                  <a:ext uri="{0D108BD9-81ED-4DB2-BD59-A6C34878D82A}">
                    <a16:rowId xmlns:a16="http://schemas.microsoft.com/office/drawing/2014/main" val="1560300694"/>
                  </a:ext>
                </a:extLst>
              </a:tr>
              <a:tr h="164592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Degenerativ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onservativ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Ye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PK" sz="1100" u="none" strike="noStrike">
                          <a:effectLst/>
                        </a:rPr>
                        <a:t>7</a:t>
                      </a:r>
                      <a:endParaRPr lang="en-PK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extLst>
                  <a:ext uri="{0D108BD9-81ED-4DB2-BD59-A6C34878D82A}">
                    <a16:rowId xmlns:a16="http://schemas.microsoft.com/office/drawing/2014/main" val="1741570584"/>
                  </a:ext>
                </a:extLst>
              </a:tr>
              <a:tr h="164592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Degenerativ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onservativ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Ye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PK" sz="1100" u="none" strike="noStrike">
                          <a:effectLst/>
                        </a:rPr>
                        <a:t>1,4,6</a:t>
                      </a:r>
                      <a:endParaRPr lang="en-PK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extLst>
                  <a:ext uri="{0D108BD9-81ED-4DB2-BD59-A6C34878D82A}">
                    <a16:rowId xmlns:a16="http://schemas.microsoft.com/office/drawing/2014/main" val="2909793296"/>
                  </a:ext>
                </a:extLst>
              </a:tr>
              <a:tr h="164592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Degenerativ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onservativ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1, Exceptional Metal in 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extLst>
                  <a:ext uri="{0D108BD9-81ED-4DB2-BD59-A6C34878D82A}">
                    <a16:rowId xmlns:a16="http://schemas.microsoft.com/office/drawing/2014/main" val="1446706919"/>
                  </a:ext>
                </a:extLst>
              </a:tr>
              <a:tr h="164592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Degenerativ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onservative 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PK" sz="1100" u="none" strike="noStrike">
                          <a:effectLst/>
                        </a:rPr>
                        <a:t>1</a:t>
                      </a:r>
                      <a:endParaRPr lang="en-PK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extLst>
                  <a:ext uri="{0D108BD9-81ED-4DB2-BD59-A6C34878D82A}">
                    <a16:rowId xmlns:a16="http://schemas.microsoft.com/office/drawing/2014/main" val="1007875368"/>
                  </a:ext>
                </a:extLst>
              </a:tr>
              <a:tr h="164592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Degenerativ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onservativ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Ye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PK" sz="1100" u="none" strike="noStrike">
                          <a:effectLst/>
                        </a:rPr>
                        <a:t>1,7</a:t>
                      </a:r>
                      <a:endParaRPr lang="en-PK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extLst>
                  <a:ext uri="{0D108BD9-81ED-4DB2-BD59-A6C34878D82A}">
                    <a16:rowId xmlns:a16="http://schemas.microsoft.com/office/drawing/2014/main" val="1344271481"/>
                  </a:ext>
                </a:extLst>
              </a:tr>
              <a:tr h="164592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Degenerativ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onservativ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Ye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PK" sz="1100" u="none" strike="noStrike">
                          <a:effectLst/>
                        </a:rPr>
                        <a:t>1,4</a:t>
                      </a:r>
                      <a:endParaRPr lang="en-PK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extLst>
                  <a:ext uri="{0D108BD9-81ED-4DB2-BD59-A6C34878D82A}">
                    <a16:rowId xmlns:a16="http://schemas.microsoft.com/office/drawing/2014/main" val="2248830880"/>
                  </a:ext>
                </a:extLst>
              </a:tr>
              <a:tr h="164592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Traum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Surgery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Ye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Ye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Ye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extLst>
                  <a:ext uri="{0D108BD9-81ED-4DB2-BD59-A6C34878D82A}">
                    <a16:rowId xmlns:a16="http://schemas.microsoft.com/office/drawing/2014/main" val="2541700163"/>
                  </a:ext>
                </a:extLst>
              </a:tr>
              <a:tr h="164592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Degenerativ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onservativ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PK" sz="1100" u="none" strike="noStrike">
                          <a:effectLst/>
                        </a:rPr>
                        <a:t>1,4,5</a:t>
                      </a:r>
                      <a:endParaRPr lang="en-PK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extLst>
                  <a:ext uri="{0D108BD9-81ED-4DB2-BD59-A6C34878D82A}">
                    <a16:rowId xmlns:a16="http://schemas.microsoft.com/office/drawing/2014/main" val="2129968709"/>
                  </a:ext>
                </a:extLst>
              </a:tr>
              <a:tr h="164592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Degenerativ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onservativ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PK" sz="1100" u="none" strike="noStrike">
                          <a:effectLst/>
                        </a:rPr>
                        <a:t>1,4,5</a:t>
                      </a:r>
                      <a:endParaRPr lang="en-PK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extLst>
                  <a:ext uri="{0D108BD9-81ED-4DB2-BD59-A6C34878D82A}">
                    <a16:rowId xmlns:a16="http://schemas.microsoft.com/office/drawing/2014/main" val="3110085519"/>
                  </a:ext>
                </a:extLst>
              </a:tr>
              <a:tr h="164592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Degenerativ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onservativ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Yes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PK" sz="1100" u="none" strike="noStrike">
                          <a:effectLst/>
                        </a:rPr>
                        <a:t>4,5</a:t>
                      </a:r>
                      <a:endParaRPr lang="en-PK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extLst>
                  <a:ext uri="{0D108BD9-81ED-4DB2-BD59-A6C34878D82A}">
                    <a16:rowId xmlns:a16="http://schemas.microsoft.com/office/drawing/2014/main" val="4026707885"/>
                  </a:ext>
                </a:extLst>
              </a:tr>
              <a:tr h="164592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Degenerativ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onservativ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Ye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extLst>
                  <a:ext uri="{0D108BD9-81ED-4DB2-BD59-A6C34878D82A}">
                    <a16:rowId xmlns:a16="http://schemas.microsoft.com/office/drawing/2014/main" val="1951209440"/>
                  </a:ext>
                </a:extLst>
              </a:tr>
              <a:tr h="164592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Degenerativ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onservativ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Ye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PK" sz="1100" u="none" strike="noStrike">
                          <a:effectLst/>
                        </a:rPr>
                        <a:t>1,4,5</a:t>
                      </a:r>
                      <a:endParaRPr lang="en-PK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extLst>
                  <a:ext uri="{0D108BD9-81ED-4DB2-BD59-A6C34878D82A}">
                    <a16:rowId xmlns:a16="http://schemas.microsoft.com/office/drawing/2014/main" val="1792064018"/>
                  </a:ext>
                </a:extLst>
              </a:tr>
              <a:tr h="164592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Degenerativ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onservativ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Ye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extLst>
                  <a:ext uri="{0D108BD9-81ED-4DB2-BD59-A6C34878D82A}">
                    <a16:rowId xmlns:a16="http://schemas.microsoft.com/office/drawing/2014/main" val="1724778213"/>
                  </a:ext>
                </a:extLst>
              </a:tr>
              <a:tr h="164592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Traum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rthroscopy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Ye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Ye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extLst>
                  <a:ext uri="{0D108BD9-81ED-4DB2-BD59-A6C34878D82A}">
                    <a16:rowId xmlns:a16="http://schemas.microsoft.com/office/drawing/2014/main" val="3656367482"/>
                  </a:ext>
                </a:extLst>
              </a:tr>
              <a:tr h="164592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Degenerativ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onservativ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Ye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Ye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extLst>
                  <a:ext uri="{0D108BD9-81ED-4DB2-BD59-A6C34878D82A}">
                    <a16:rowId xmlns:a16="http://schemas.microsoft.com/office/drawing/2014/main" val="3473989961"/>
                  </a:ext>
                </a:extLst>
              </a:tr>
              <a:tr h="164592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Degenerativ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onservativ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Ye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PK" sz="1100" u="none" strike="noStrike">
                          <a:effectLst/>
                        </a:rPr>
                        <a:t>1,4,5,8</a:t>
                      </a:r>
                      <a:endParaRPr lang="en-PK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extLst>
                  <a:ext uri="{0D108BD9-81ED-4DB2-BD59-A6C34878D82A}">
                    <a16:rowId xmlns:a16="http://schemas.microsoft.com/office/drawing/2014/main" val="4147408771"/>
                  </a:ext>
                </a:extLst>
              </a:tr>
              <a:tr h="164592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Degenerativ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onservativ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Ye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PK" sz="1100" u="none" strike="noStrike">
                          <a:effectLst/>
                        </a:rPr>
                        <a:t>1,4,5</a:t>
                      </a:r>
                      <a:endParaRPr lang="en-PK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extLst>
                  <a:ext uri="{0D108BD9-81ED-4DB2-BD59-A6C34878D82A}">
                    <a16:rowId xmlns:a16="http://schemas.microsoft.com/office/drawing/2014/main" val="1153817696"/>
                  </a:ext>
                </a:extLst>
              </a:tr>
              <a:tr h="164592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Degenerativ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onservativ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PK" sz="1100" u="none" strike="noStrike">
                          <a:effectLst/>
                        </a:rPr>
                        <a:t>1,4,5,7</a:t>
                      </a:r>
                      <a:endParaRPr lang="en-PK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extLst>
                  <a:ext uri="{0D108BD9-81ED-4DB2-BD59-A6C34878D82A}">
                    <a16:rowId xmlns:a16="http://schemas.microsoft.com/office/drawing/2014/main" val="90388228"/>
                  </a:ext>
                </a:extLst>
              </a:tr>
              <a:tr h="164592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Degenerativ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onservativ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PK" sz="1100" u="none" strike="noStrike">
                          <a:effectLst/>
                        </a:rPr>
                        <a:t>1,4,5</a:t>
                      </a:r>
                      <a:endParaRPr lang="en-PK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extLst>
                  <a:ext uri="{0D108BD9-81ED-4DB2-BD59-A6C34878D82A}">
                    <a16:rowId xmlns:a16="http://schemas.microsoft.com/office/drawing/2014/main" val="3829382751"/>
                  </a:ext>
                </a:extLst>
              </a:tr>
              <a:tr h="164592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Degenerativ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onservativ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PK" sz="1100" u="none" strike="noStrike">
                          <a:effectLst/>
                        </a:rPr>
                        <a:t>1,4,5,6</a:t>
                      </a:r>
                      <a:endParaRPr lang="en-PK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extLst>
                  <a:ext uri="{0D108BD9-81ED-4DB2-BD59-A6C34878D82A}">
                    <a16:rowId xmlns:a16="http://schemas.microsoft.com/office/drawing/2014/main" val="3494434222"/>
                  </a:ext>
                </a:extLst>
              </a:tr>
              <a:tr h="164592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Degenerativ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onservativ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PK" sz="1100" u="none" strike="noStrike">
                          <a:effectLst/>
                        </a:rPr>
                        <a:t>1,4,5</a:t>
                      </a:r>
                      <a:endParaRPr lang="en-PK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extLst>
                  <a:ext uri="{0D108BD9-81ED-4DB2-BD59-A6C34878D82A}">
                    <a16:rowId xmlns:a16="http://schemas.microsoft.com/office/drawing/2014/main" val="252150548"/>
                  </a:ext>
                </a:extLst>
              </a:tr>
              <a:tr h="164592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Degenerativ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onservativ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Ye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PK" sz="1100" u="none" strike="noStrike">
                          <a:effectLst/>
                        </a:rPr>
                        <a:t>1,4,5</a:t>
                      </a:r>
                      <a:endParaRPr lang="en-PK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extLst>
                  <a:ext uri="{0D108BD9-81ED-4DB2-BD59-A6C34878D82A}">
                    <a16:rowId xmlns:a16="http://schemas.microsoft.com/office/drawing/2014/main" val="4000473071"/>
                  </a:ext>
                </a:extLst>
              </a:tr>
              <a:tr h="164592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Degenerativ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onservativ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Ye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Ye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Yes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9" marR="2439" marT="2439" marB="0" anchor="b"/>
                </a:tc>
                <a:extLst>
                  <a:ext uri="{0D108BD9-81ED-4DB2-BD59-A6C34878D82A}">
                    <a16:rowId xmlns:a16="http://schemas.microsoft.com/office/drawing/2014/main" val="305277319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8487533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319</Words>
  <Application>Microsoft Office PowerPoint</Application>
  <PresentationFormat>Widescreen</PresentationFormat>
  <Paragraphs>28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r. Muhammad Murtaza khan</dc:creator>
  <cp:lastModifiedBy>Mr. Muhammad Murtaza khan</cp:lastModifiedBy>
  <cp:revision>1</cp:revision>
  <dcterms:created xsi:type="dcterms:W3CDTF">2021-08-15T00:35:23Z</dcterms:created>
  <dcterms:modified xsi:type="dcterms:W3CDTF">2021-08-15T00:40:48Z</dcterms:modified>
</cp:coreProperties>
</file>